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8" r:id="rId2"/>
    <p:sldId id="273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12"/>
    <p:restoredTop sz="94729"/>
  </p:normalViewPr>
  <p:slideViewPr>
    <p:cSldViewPr snapToGrid="0" snapToObjects="1">
      <p:cViewPr varScale="1">
        <p:scale>
          <a:sx n="87" d="100"/>
          <a:sy n="87" d="100"/>
        </p:scale>
        <p:origin x="-3222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C39DCA-8A7A-D84C-851C-B7DF1C57CDD3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F62C23-1758-1C4A-A715-05101F141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7815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71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167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162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406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289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026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264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90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25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785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547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F3301-7F51-4A47-BE0E-9071243FAE7A}" type="datetimeFigureOut">
              <a:rPr lang="en-US" smtClean="0"/>
              <a:t>9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6ED79-36EA-8B4E-B1EA-E56D7613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947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7532D81-D6B9-6148-88DA-A60A1AD60D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t="19595" r="-67"/>
          <a:stretch/>
        </p:blipFill>
        <p:spPr>
          <a:xfrm>
            <a:off x="3370835" y="3993522"/>
            <a:ext cx="2920112" cy="23166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8FF3EFE5-3100-B948-BE78-BA69FAA9E3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t="19595" r="-2491"/>
          <a:stretch/>
        </p:blipFill>
        <p:spPr>
          <a:xfrm>
            <a:off x="3370835" y="833160"/>
            <a:ext cx="2925057" cy="225144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D126E59-EF91-E440-A06F-EA8FDB8EA7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550" t="9503" r="25848" b="9207"/>
          <a:stretch/>
        </p:blipFill>
        <p:spPr>
          <a:xfrm>
            <a:off x="567053" y="474877"/>
            <a:ext cx="2656419" cy="603078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BD417D81-772F-C145-B409-E3FCC401E523}"/>
              </a:ext>
            </a:extLst>
          </p:cNvPr>
          <p:cNvSpPr txBox="1"/>
          <p:nvPr/>
        </p:nvSpPr>
        <p:spPr>
          <a:xfrm>
            <a:off x="5815579" y="55498"/>
            <a:ext cx="984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Figure S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65FBC7A9-ECED-F640-87E2-00E4524DE341}"/>
              </a:ext>
            </a:extLst>
          </p:cNvPr>
          <p:cNvSpPr txBox="1"/>
          <p:nvPr/>
        </p:nvSpPr>
        <p:spPr>
          <a:xfrm>
            <a:off x="103574" y="525383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568AC551-E870-7E47-8E4F-FA75D78E4A54}"/>
              </a:ext>
            </a:extLst>
          </p:cNvPr>
          <p:cNvSpPr txBox="1"/>
          <p:nvPr/>
        </p:nvSpPr>
        <p:spPr>
          <a:xfrm>
            <a:off x="103574" y="3929354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xmlns="" id="{FB2B726F-8E64-5149-A4AF-EA889E6CC7F4}"/>
              </a:ext>
            </a:extLst>
          </p:cNvPr>
          <p:cNvCxnSpPr>
            <a:cxnSpLocks/>
          </p:cNvCxnSpPr>
          <p:nvPr/>
        </p:nvCxnSpPr>
        <p:spPr>
          <a:xfrm>
            <a:off x="708131" y="6562155"/>
            <a:ext cx="59355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8AC394B5-59B0-7840-9FF5-DFCA0BBF6A75}"/>
              </a:ext>
            </a:extLst>
          </p:cNvPr>
          <p:cNvSpPr txBox="1"/>
          <p:nvPr/>
        </p:nvSpPr>
        <p:spPr>
          <a:xfrm>
            <a:off x="1256699" y="6408266"/>
            <a:ext cx="593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CTY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D77BE3C4-9205-E940-9DDD-F6B5FEE24785}"/>
              </a:ext>
            </a:extLst>
          </p:cNvPr>
          <p:cNvGrpSpPr/>
          <p:nvPr/>
        </p:nvGrpSpPr>
        <p:grpSpPr>
          <a:xfrm>
            <a:off x="423437" y="2159740"/>
            <a:ext cx="2023179" cy="1284364"/>
            <a:chOff x="11884" y="2165683"/>
            <a:chExt cx="2023179" cy="1284364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xmlns="" id="{D694DE64-1F84-1242-B791-FB30BE7F3F8F}"/>
                </a:ext>
              </a:extLst>
            </p:cNvPr>
            <p:cNvGrpSpPr/>
            <p:nvPr/>
          </p:nvGrpSpPr>
          <p:grpSpPr>
            <a:xfrm>
              <a:off x="101132" y="2861063"/>
              <a:ext cx="593558" cy="481263"/>
              <a:chOff x="1138989" y="7267074"/>
              <a:chExt cx="593558" cy="481263"/>
            </a:xfrm>
          </p:grpSpPr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xmlns="" id="{7973E4F3-45E0-3C40-8B85-AB370E2C9C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8989" y="7748337"/>
                <a:ext cx="59355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xmlns="" id="{8882671D-0418-C844-A306-E6B604F8A16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138989" y="7267074"/>
                <a:ext cx="8021" cy="48126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4C2AF0B9-8310-3A42-95BF-CE3EB2BE42D6}"/>
                </a:ext>
              </a:extLst>
            </p:cNvPr>
            <p:cNvSpPr txBox="1"/>
            <p:nvPr/>
          </p:nvSpPr>
          <p:spPr>
            <a:xfrm>
              <a:off x="419690" y="3188437"/>
              <a:ext cx="16153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Helvetica" pitchFamily="2" charset="0"/>
                </a:rPr>
                <a:t>Zombie Aqu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85D31949-DAAE-AB48-852D-A7118F04EF92}"/>
                </a:ext>
              </a:extLst>
            </p:cNvPr>
            <p:cNvSpPr txBox="1"/>
            <p:nvPr/>
          </p:nvSpPr>
          <p:spPr>
            <a:xfrm rot="16200000">
              <a:off x="-282342" y="2459909"/>
              <a:ext cx="850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Helvetica" pitchFamily="2" charset="0"/>
                </a:rPr>
                <a:t>FSC-H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971A9A35-10A2-A94E-90B7-03A9B4C30FC9}"/>
              </a:ext>
            </a:extLst>
          </p:cNvPr>
          <p:cNvSpPr txBox="1"/>
          <p:nvPr/>
        </p:nvSpPr>
        <p:spPr>
          <a:xfrm rot="16200000">
            <a:off x="-59497" y="1216333"/>
            <a:ext cx="793275" cy="286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Control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2C0FA28A-DC1A-2841-B4A9-6D65F29D7917}"/>
              </a:ext>
            </a:extLst>
          </p:cNvPr>
          <p:cNvSpPr txBox="1"/>
          <p:nvPr/>
        </p:nvSpPr>
        <p:spPr>
          <a:xfrm rot="16200000">
            <a:off x="-299706" y="2440217"/>
            <a:ext cx="1273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DADA2 Pt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81511FC-EE3C-D349-BCE2-0721E80AAE23}"/>
              </a:ext>
            </a:extLst>
          </p:cNvPr>
          <p:cNvSpPr txBox="1"/>
          <p:nvPr/>
        </p:nvSpPr>
        <p:spPr>
          <a:xfrm rot="16200000">
            <a:off x="135237" y="4306676"/>
            <a:ext cx="793275" cy="286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Control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02B9564-18E1-F048-9BAA-0CF2B9E5E80C}"/>
              </a:ext>
            </a:extLst>
          </p:cNvPr>
          <p:cNvSpPr txBox="1"/>
          <p:nvPr/>
        </p:nvSpPr>
        <p:spPr>
          <a:xfrm rot="16200000">
            <a:off x="-104972" y="5530560"/>
            <a:ext cx="1273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DADA2 Pt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5E182348-4F3D-0F4D-BB01-8FBDC86FD19F}"/>
              </a:ext>
            </a:extLst>
          </p:cNvPr>
          <p:cNvSpPr txBox="1"/>
          <p:nvPr/>
        </p:nvSpPr>
        <p:spPr>
          <a:xfrm>
            <a:off x="574990" y="783242"/>
            <a:ext cx="756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Viable cell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13BDE886-B2D6-2144-99D6-C5610A939A77}"/>
              </a:ext>
            </a:extLst>
          </p:cNvPr>
          <p:cNvSpPr txBox="1"/>
          <p:nvPr/>
        </p:nvSpPr>
        <p:spPr>
          <a:xfrm>
            <a:off x="1777257" y="802382"/>
            <a:ext cx="756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Viable cell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39B0DE70-45AC-124E-B76F-F7E00811AFEA}"/>
              </a:ext>
            </a:extLst>
          </p:cNvPr>
          <p:cNvSpPr txBox="1"/>
          <p:nvPr/>
        </p:nvSpPr>
        <p:spPr>
          <a:xfrm>
            <a:off x="591561" y="1994233"/>
            <a:ext cx="756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Viable cell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A4FAD88C-875E-1348-BE70-7FD4BC717914}"/>
              </a:ext>
            </a:extLst>
          </p:cNvPr>
          <p:cNvSpPr txBox="1"/>
          <p:nvPr/>
        </p:nvSpPr>
        <p:spPr>
          <a:xfrm>
            <a:off x="1793828" y="2013373"/>
            <a:ext cx="7564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Helvetica" pitchFamily="2" charset="0"/>
              </a:rPr>
              <a:t>Viable cell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xmlns="" id="{105A5F8C-870C-E343-83B5-189FBA2E3D40}"/>
              </a:ext>
            </a:extLst>
          </p:cNvPr>
          <p:cNvSpPr/>
          <p:nvPr/>
        </p:nvSpPr>
        <p:spPr>
          <a:xfrm>
            <a:off x="4140393" y="3951189"/>
            <a:ext cx="1547246" cy="3601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AA9C25AC-185A-8B41-B6F6-BDAD6E025E38}"/>
              </a:ext>
            </a:extLst>
          </p:cNvPr>
          <p:cNvSpPr/>
          <p:nvPr/>
        </p:nvSpPr>
        <p:spPr>
          <a:xfrm>
            <a:off x="4057268" y="783242"/>
            <a:ext cx="1547246" cy="3601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22122320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BC9BA3E9-F0E1-7E44-8C83-BEA627312C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4372" y="192452"/>
            <a:ext cx="1601868" cy="143745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34246527-8856-FF40-9716-88081A1AD9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222" t="16998" r="15478" b="60724"/>
          <a:stretch/>
        </p:blipFill>
        <p:spPr>
          <a:xfrm>
            <a:off x="716313" y="440713"/>
            <a:ext cx="1992065" cy="947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89F6892-5793-F249-B8CE-60AD109A0852}"/>
              </a:ext>
            </a:extLst>
          </p:cNvPr>
          <p:cNvSpPr txBox="1"/>
          <p:nvPr/>
        </p:nvSpPr>
        <p:spPr>
          <a:xfrm>
            <a:off x="5873067" y="38564"/>
            <a:ext cx="984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Figure 2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D80081F-3E58-3F43-8883-78C710CA47FC}"/>
              </a:ext>
            </a:extLst>
          </p:cNvPr>
          <p:cNvSpPr txBox="1"/>
          <p:nvPr/>
        </p:nvSpPr>
        <p:spPr>
          <a:xfrm>
            <a:off x="372017" y="286825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68E53F38-E966-EA43-994D-A4E0C50B5F36}"/>
              </a:ext>
            </a:extLst>
          </p:cNvPr>
          <p:cNvSpPr txBox="1"/>
          <p:nvPr/>
        </p:nvSpPr>
        <p:spPr>
          <a:xfrm>
            <a:off x="372017" y="1662303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F09EA94-D546-854A-9FA8-0FD75B11ACED}"/>
              </a:ext>
            </a:extLst>
          </p:cNvPr>
          <p:cNvSpPr txBox="1"/>
          <p:nvPr/>
        </p:nvSpPr>
        <p:spPr>
          <a:xfrm>
            <a:off x="372017" y="2972169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8DDB996-05AD-3447-AE9D-D3934EAE219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502" t="15914" r="43797" b="14530"/>
          <a:stretch/>
        </p:blipFill>
        <p:spPr>
          <a:xfrm>
            <a:off x="667346" y="1683394"/>
            <a:ext cx="2040429" cy="250013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1F95838F-5591-2943-90D6-8681C46D71D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032" r="5803" b="10576"/>
          <a:stretch/>
        </p:blipFill>
        <p:spPr>
          <a:xfrm>
            <a:off x="3163978" y="1528365"/>
            <a:ext cx="2313168" cy="143745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1BDED601-3E2F-EA46-A89C-B5ABD57B2EC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6641" r="-359"/>
          <a:stretch/>
        </p:blipFill>
        <p:spPr>
          <a:xfrm>
            <a:off x="3199621" y="2968832"/>
            <a:ext cx="2300675" cy="1437454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8CE6232F-2B23-6342-AA52-BF780AC07205}"/>
              </a:ext>
            </a:extLst>
          </p:cNvPr>
          <p:cNvGrpSpPr/>
          <p:nvPr/>
        </p:nvGrpSpPr>
        <p:grpSpPr>
          <a:xfrm>
            <a:off x="508525" y="295719"/>
            <a:ext cx="944628" cy="1291821"/>
            <a:chOff x="508525" y="249419"/>
            <a:chExt cx="944628" cy="1291821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B6BA08F1-A525-F343-AAE0-AD276B412A06}"/>
                </a:ext>
              </a:extLst>
            </p:cNvPr>
            <p:cNvGrpSpPr/>
            <p:nvPr/>
          </p:nvGrpSpPr>
          <p:grpSpPr>
            <a:xfrm>
              <a:off x="608623" y="1116032"/>
              <a:ext cx="258628" cy="307777"/>
              <a:chOff x="1138989" y="7338483"/>
              <a:chExt cx="593558" cy="409854"/>
            </a:xfrm>
          </p:grpSpPr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xmlns="" id="{A08DE3E9-6442-974C-9B2B-C15E3725B9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8989" y="7748337"/>
                <a:ext cx="59355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xmlns="" id="{078F92D7-FE9B-A040-8D19-5129E81A190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010" y="7338483"/>
                <a:ext cx="0" cy="40985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DD94D4B3-A03A-3149-96C7-E7C47CB3A54E}"/>
                </a:ext>
              </a:extLst>
            </p:cNvPr>
            <p:cNvSpPr txBox="1"/>
            <p:nvPr/>
          </p:nvSpPr>
          <p:spPr>
            <a:xfrm rot="16200000">
              <a:off x="178996" y="578948"/>
              <a:ext cx="9206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SSC-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D940AC62-A7DB-1446-AD1A-3C5A07ABCB3D}"/>
                </a:ext>
              </a:extLst>
            </p:cNvPr>
            <p:cNvSpPr txBox="1"/>
            <p:nvPr/>
          </p:nvSpPr>
          <p:spPr>
            <a:xfrm>
              <a:off x="824325" y="1279630"/>
              <a:ext cx="6288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CD3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4FE928D6-EBF2-024E-8FA8-92FB88CF5570}"/>
              </a:ext>
            </a:extLst>
          </p:cNvPr>
          <p:cNvSpPr txBox="1"/>
          <p:nvPr/>
        </p:nvSpPr>
        <p:spPr>
          <a:xfrm rot="16200000">
            <a:off x="-268673" y="921327"/>
            <a:ext cx="1140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Lymphocytes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771FA1C2-1E92-BF4F-94A6-94636ACEC666}"/>
              </a:ext>
            </a:extLst>
          </p:cNvPr>
          <p:cNvGrpSpPr/>
          <p:nvPr/>
        </p:nvGrpSpPr>
        <p:grpSpPr>
          <a:xfrm>
            <a:off x="432235" y="3211031"/>
            <a:ext cx="967876" cy="1155667"/>
            <a:chOff x="485277" y="385573"/>
            <a:chExt cx="967876" cy="1155667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xmlns="" id="{5B905C75-9919-F54B-9A9A-39B0A85FDBB7}"/>
                </a:ext>
              </a:extLst>
            </p:cNvPr>
            <p:cNvGrpSpPr/>
            <p:nvPr/>
          </p:nvGrpSpPr>
          <p:grpSpPr>
            <a:xfrm>
              <a:off x="608623" y="1116032"/>
              <a:ext cx="258628" cy="307777"/>
              <a:chOff x="1138989" y="7338483"/>
              <a:chExt cx="593558" cy="409854"/>
            </a:xfrm>
          </p:grpSpPr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xmlns="" id="{72D3A143-AA55-B441-AD66-EBB0A5650C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8989" y="7748337"/>
                <a:ext cx="59355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xmlns="" id="{BEC2270E-86C3-0C46-B890-F76A71B83D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010" y="7338483"/>
                <a:ext cx="0" cy="40985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ED6BADB0-942F-3E41-9CB4-167F08CD4601}"/>
                </a:ext>
              </a:extLst>
            </p:cNvPr>
            <p:cNvSpPr txBox="1"/>
            <p:nvPr/>
          </p:nvSpPr>
          <p:spPr>
            <a:xfrm rot="16200000">
              <a:off x="223168" y="647682"/>
              <a:ext cx="7858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CXCR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86CE7F77-76C5-3149-9393-09EB85E85095}"/>
                </a:ext>
              </a:extLst>
            </p:cNvPr>
            <p:cNvSpPr txBox="1"/>
            <p:nvPr/>
          </p:nvSpPr>
          <p:spPr>
            <a:xfrm>
              <a:off x="824325" y="1279630"/>
              <a:ext cx="6288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CCR6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E80D1377-3B39-4A41-855F-C9DF22415A57}"/>
              </a:ext>
            </a:extLst>
          </p:cNvPr>
          <p:cNvSpPr txBox="1"/>
          <p:nvPr/>
        </p:nvSpPr>
        <p:spPr>
          <a:xfrm rot="16200000">
            <a:off x="-19750" y="3386946"/>
            <a:ext cx="62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cTfh</a:t>
            </a:r>
            <a:endParaRPr lang="en-US" sz="1200" dirty="0">
              <a:latin typeface="Helvetica" pitchFamily="2" charset="0"/>
            </a:endParaRP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xmlns="" id="{7CBD78FB-C82C-884F-A8B0-2290959344FE}"/>
              </a:ext>
            </a:extLst>
          </p:cNvPr>
          <p:cNvGrpSpPr/>
          <p:nvPr/>
        </p:nvGrpSpPr>
        <p:grpSpPr>
          <a:xfrm>
            <a:off x="412978" y="1744342"/>
            <a:ext cx="967876" cy="1223426"/>
            <a:chOff x="485277" y="317814"/>
            <a:chExt cx="967876" cy="1223426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557BFE3E-A9BD-7547-89C0-2B4AAF3B752F}"/>
                </a:ext>
              </a:extLst>
            </p:cNvPr>
            <p:cNvGrpSpPr/>
            <p:nvPr/>
          </p:nvGrpSpPr>
          <p:grpSpPr>
            <a:xfrm>
              <a:off x="608623" y="1116032"/>
              <a:ext cx="258628" cy="307777"/>
              <a:chOff x="1138989" y="7338483"/>
              <a:chExt cx="593558" cy="409854"/>
            </a:xfrm>
          </p:grpSpPr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xmlns="" id="{AB5F6DAC-C07F-A54E-ADF7-B551E90AFA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38989" y="7748337"/>
                <a:ext cx="593558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>
                <a:extLst>
                  <a:ext uri="{FF2B5EF4-FFF2-40B4-BE49-F238E27FC236}">
                    <a16:creationId xmlns:a16="http://schemas.microsoft.com/office/drawing/2014/main" xmlns="" id="{EF474431-08D9-B04D-A697-8B4E6B89730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47010" y="7338483"/>
                <a:ext cx="0" cy="40985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AC135485-799D-AA44-B233-92C2F5503BE0}"/>
                </a:ext>
              </a:extLst>
            </p:cNvPr>
            <p:cNvSpPr txBox="1"/>
            <p:nvPr/>
          </p:nvSpPr>
          <p:spPr>
            <a:xfrm rot="16200000">
              <a:off x="189289" y="613802"/>
              <a:ext cx="85358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CXCR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F3B9268B-2452-AF48-9E00-F7649E810AE2}"/>
                </a:ext>
              </a:extLst>
            </p:cNvPr>
            <p:cNvSpPr txBox="1"/>
            <p:nvPr/>
          </p:nvSpPr>
          <p:spPr>
            <a:xfrm>
              <a:off x="824325" y="1279630"/>
              <a:ext cx="62882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CCR6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AB56F194-D72C-1C48-BC05-8856ED94D803}"/>
              </a:ext>
            </a:extLst>
          </p:cNvPr>
          <p:cNvSpPr txBox="1"/>
          <p:nvPr/>
        </p:nvSpPr>
        <p:spPr>
          <a:xfrm rot="16200000">
            <a:off x="-313207" y="2219752"/>
            <a:ext cx="12278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Memory CD4</a:t>
            </a:r>
            <a:r>
              <a:rPr lang="en-US" sz="1200" baseline="30000" dirty="0">
                <a:latin typeface="Helvetica" pitchFamily="2" charset="0"/>
              </a:rPr>
              <a:t>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56D44096-9518-1B45-9457-CB8DE331C697}"/>
              </a:ext>
            </a:extLst>
          </p:cNvPr>
          <p:cNvSpPr txBox="1"/>
          <p:nvPr/>
        </p:nvSpPr>
        <p:spPr>
          <a:xfrm>
            <a:off x="1485550" y="112850"/>
            <a:ext cx="1273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DADA2 Pt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D498F247-0DC9-9846-97F6-B9FDC5E42EA6}"/>
              </a:ext>
            </a:extLst>
          </p:cNvPr>
          <p:cNvSpPr txBox="1"/>
          <p:nvPr/>
        </p:nvSpPr>
        <p:spPr>
          <a:xfrm>
            <a:off x="727697" y="62074"/>
            <a:ext cx="959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Healthy controls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xmlns="" id="{228817A5-3690-0D4D-9977-85D9A25535DD}"/>
              </a:ext>
            </a:extLst>
          </p:cNvPr>
          <p:cNvSpPr/>
          <p:nvPr/>
        </p:nvSpPr>
        <p:spPr>
          <a:xfrm>
            <a:off x="3654345" y="1525353"/>
            <a:ext cx="1460753" cy="2133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xmlns="" id="{F05F75D6-C206-4542-A207-23061BA26DF5}"/>
              </a:ext>
            </a:extLst>
          </p:cNvPr>
          <p:cNvSpPr/>
          <p:nvPr/>
        </p:nvSpPr>
        <p:spPr>
          <a:xfrm>
            <a:off x="3783381" y="4798423"/>
            <a:ext cx="1406587" cy="2976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xmlns="" id="{CDFB759C-6DAB-BD4B-A543-8DF764AA3DCA}"/>
              </a:ext>
            </a:extLst>
          </p:cNvPr>
          <p:cNvSpPr/>
          <p:nvPr/>
        </p:nvSpPr>
        <p:spPr>
          <a:xfrm>
            <a:off x="3652753" y="2974604"/>
            <a:ext cx="1460753" cy="1939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37529868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277F43C3-2F70-4349-9405-C55396192530}"/>
              </a:ext>
            </a:extLst>
          </p:cNvPr>
          <p:cNvSpPr txBox="1"/>
          <p:nvPr/>
        </p:nvSpPr>
        <p:spPr>
          <a:xfrm>
            <a:off x="5873067" y="38564"/>
            <a:ext cx="984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Figure S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DCA50B5-5CDF-BC48-9A8D-A74560A476A5}"/>
              </a:ext>
            </a:extLst>
          </p:cNvPr>
          <p:cNvSpPr txBox="1"/>
          <p:nvPr/>
        </p:nvSpPr>
        <p:spPr>
          <a:xfrm>
            <a:off x="62723" y="286825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A97FC38D-D19B-AB4A-A0FF-ECD1CFAA2046}"/>
              </a:ext>
            </a:extLst>
          </p:cNvPr>
          <p:cNvSpPr txBox="1"/>
          <p:nvPr/>
        </p:nvSpPr>
        <p:spPr>
          <a:xfrm>
            <a:off x="59012" y="1884553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91E6B02-80F2-814F-9355-A845540C623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447" t="11543" r="15949" b="19774"/>
          <a:stretch/>
        </p:blipFill>
        <p:spPr>
          <a:xfrm>
            <a:off x="752354" y="2192330"/>
            <a:ext cx="1796109" cy="266217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9F5CEBD9-8F8D-4D43-BBE0-097A929A25A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18"/>
          <a:stretch/>
        </p:blipFill>
        <p:spPr>
          <a:xfrm>
            <a:off x="0" y="5517384"/>
            <a:ext cx="6858000" cy="435005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AF00AB20-4101-5044-8009-13123D25DA3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715" r="-357"/>
          <a:stretch/>
        </p:blipFill>
        <p:spPr>
          <a:xfrm>
            <a:off x="2770410" y="2523769"/>
            <a:ext cx="2410799" cy="171256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7D16B987-1E7F-5547-B94E-E5DDE38E8B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48463" y="150788"/>
            <a:ext cx="1793156" cy="142090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46ABBDE6-9D2B-9246-97D6-5C132931023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116" r="17974" b="394"/>
          <a:stretch/>
        </p:blipFill>
        <p:spPr>
          <a:xfrm>
            <a:off x="488388" y="321238"/>
            <a:ext cx="1456159" cy="1268480"/>
          </a:xfrm>
          <a:prstGeom prst="rect">
            <a:avLst/>
          </a:prstGeom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8E6A0348-4E8E-6B4D-9CE3-60D8D9E0188E}"/>
              </a:ext>
            </a:extLst>
          </p:cNvPr>
          <p:cNvGrpSpPr/>
          <p:nvPr/>
        </p:nvGrpSpPr>
        <p:grpSpPr>
          <a:xfrm>
            <a:off x="794716" y="4820798"/>
            <a:ext cx="734690" cy="184989"/>
            <a:chOff x="608623" y="1279630"/>
            <a:chExt cx="977872" cy="246221"/>
          </a:xfrm>
        </p:grpSpPr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xmlns="" id="{C7C7FA16-18C6-124F-993D-870F042C11CB}"/>
                </a:ext>
              </a:extLst>
            </p:cNvPr>
            <p:cNvCxnSpPr>
              <a:cxnSpLocks/>
            </p:cNvCxnSpPr>
            <p:nvPr/>
          </p:nvCxnSpPr>
          <p:spPr>
            <a:xfrm>
              <a:off x="608623" y="1423809"/>
              <a:ext cx="258628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C2741D78-9BE0-6748-BE27-2E2C97814AB9}"/>
                </a:ext>
              </a:extLst>
            </p:cNvPr>
            <p:cNvSpPr txBox="1"/>
            <p:nvPr/>
          </p:nvSpPr>
          <p:spPr>
            <a:xfrm>
              <a:off x="824324" y="1279630"/>
              <a:ext cx="7621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TY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23C88CB-8155-BE4A-A73D-7576BA89A8F7}"/>
              </a:ext>
            </a:extLst>
          </p:cNvPr>
          <p:cNvSpPr txBox="1"/>
          <p:nvPr/>
        </p:nvSpPr>
        <p:spPr>
          <a:xfrm>
            <a:off x="789507" y="1826479"/>
            <a:ext cx="872603" cy="3948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Healthy Control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6D76A4EB-18E3-6D4D-8C01-26E16AD96D9B}"/>
              </a:ext>
            </a:extLst>
          </p:cNvPr>
          <p:cNvSpPr txBox="1"/>
          <p:nvPr/>
        </p:nvSpPr>
        <p:spPr>
          <a:xfrm>
            <a:off x="1496717" y="1908019"/>
            <a:ext cx="1273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DADA2 Pt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0C7837B-80F0-E142-843D-CC50B0B28395}"/>
              </a:ext>
            </a:extLst>
          </p:cNvPr>
          <p:cNvSpPr txBox="1"/>
          <p:nvPr/>
        </p:nvSpPr>
        <p:spPr>
          <a:xfrm>
            <a:off x="-18880" y="5363495"/>
            <a:ext cx="2586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D7E8EFCB-F5D4-1940-A1C0-67E946CEE3BB}"/>
              </a:ext>
            </a:extLst>
          </p:cNvPr>
          <p:cNvSpPr txBox="1"/>
          <p:nvPr/>
        </p:nvSpPr>
        <p:spPr>
          <a:xfrm>
            <a:off x="173784" y="2523769"/>
            <a:ext cx="5418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41E8BA0A-216E-E346-A1F5-AAF7A678D486}"/>
              </a:ext>
            </a:extLst>
          </p:cNvPr>
          <p:cNvSpPr txBox="1"/>
          <p:nvPr/>
        </p:nvSpPr>
        <p:spPr>
          <a:xfrm>
            <a:off x="173785" y="3337588"/>
            <a:ext cx="5418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C5B6F52-158A-9143-AA9C-1C54122A81FC}"/>
              </a:ext>
            </a:extLst>
          </p:cNvPr>
          <p:cNvSpPr txBox="1"/>
          <p:nvPr/>
        </p:nvSpPr>
        <p:spPr>
          <a:xfrm>
            <a:off x="173785" y="4166287"/>
            <a:ext cx="5563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1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6A260E99-AEB1-DD42-A423-92CD54B432D3}"/>
              </a:ext>
            </a:extLst>
          </p:cNvPr>
          <p:cNvSpPr txBox="1"/>
          <p:nvPr/>
        </p:nvSpPr>
        <p:spPr>
          <a:xfrm>
            <a:off x="888826" y="1687748"/>
            <a:ext cx="1594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Naïve CD4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 T cell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8D72A46C-B2A8-2D48-9E96-8ABB389A3BE6}"/>
              </a:ext>
            </a:extLst>
          </p:cNvPr>
          <p:cNvSpPr txBox="1"/>
          <p:nvPr/>
        </p:nvSpPr>
        <p:spPr>
          <a:xfrm>
            <a:off x="1953886" y="5279655"/>
            <a:ext cx="15949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2 cytokines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xmlns="" id="{F2E5CA95-718F-5643-9191-D2D69A1FEDD3}"/>
              </a:ext>
            </a:extLst>
          </p:cNvPr>
          <p:cNvCxnSpPr/>
          <p:nvPr/>
        </p:nvCxnSpPr>
        <p:spPr>
          <a:xfrm>
            <a:off x="488388" y="5527946"/>
            <a:ext cx="4535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BE28F9A1-0C97-2F48-8DDF-9C4B8F494260}"/>
              </a:ext>
            </a:extLst>
          </p:cNvPr>
          <p:cNvCxnSpPr>
            <a:cxnSpLocks/>
          </p:cNvCxnSpPr>
          <p:nvPr/>
        </p:nvCxnSpPr>
        <p:spPr>
          <a:xfrm>
            <a:off x="502897" y="7080883"/>
            <a:ext cx="28190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C56138D7-04FA-0A47-B385-6E67279C4E50}"/>
              </a:ext>
            </a:extLst>
          </p:cNvPr>
          <p:cNvCxnSpPr>
            <a:cxnSpLocks/>
          </p:cNvCxnSpPr>
          <p:nvPr/>
        </p:nvCxnSpPr>
        <p:spPr>
          <a:xfrm>
            <a:off x="3975809" y="7068414"/>
            <a:ext cx="28190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F8EC74EC-CDBF-1341-9BCA-7FDBD66E729F}"/>
              </a:ext>
            </a:extLst>
          </p:cNvPr>
          <p:cNvSpPr txBox="1"/>
          <p:nvPr/>
        </p:nvSpPr>
        <p:spPr>
          <a:xfrm>
            <a:off x="1114921" y="6808996"/>
            <a:ext cx="15949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17 cytokine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33422343-A78D-C84F-BF52-7782ED3125C0}"/>
              </a:ext>
            </a:extLst>
          </p:cNvPr>
          <p:cNvSpPr txBox="1"/>
          <p:nvPr/>
        </p:nvSpPr>
        <p:spPr>
          <a:xfrm>
            <a:off x="4598485" y="6814329"/>
            <a:ext cx="15949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Th1 cytokine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xmlns="" id="{E1F586C2-0C9F-914D-ACC1-F10435923254}"/>
              </a:ext>
            </a:extLst>
          </p:cNvPr>
          <p:cNvSpPr/>
          <p:nvPr/>
        </p:nvSpPr>
        <p:spPr>
          <a:xfrm>
            <a:off x="816829" y="457342"/>
            <a:ext cx="1327957" cy="1456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>
                  <a:solidFill>
                    <a:schemeClr val="bg1"/>
                  </a:solidFill>
                </a:ln>
              </a:rPr>
              <a:t>≈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xmlns="" id="{D01A20AC-EF90-4D40-962D-608E651EF4DF}"/>
              </a:ext>
            </a:extLst>
          </p:cNvPr>
          <p:cNvSpPr/>
          <p:nvPr/>
        </p:nvSpPr>
        <p:spPr>
          <a:xfrm>
            <a:off x="2874079" y="443727"/>
            <a:ext cx="1097485" cy="14569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xmlns="" id="{A798F006-3E6A-D94B-A870-43457CFF1F77}"/>
              </a:ext>
            </a:extLst>
          </p:cNvPr>
          <p:cNvSpPr/>
          <p:nvPr/>
        </p:nvSpPr>
        <p:spPr>
          <a:xfrm>
            <a:off x="3190369" y="2675097"/>
            <a:ext cx="1606828" cy="2346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xmlns="" id="{ECED698F-43D8-5D4A-88AE-AF8A1955D14B}"/>
              </a:ext>
            </a:extLst>
          </p:cNvPr>
          <p:cNvSpPr/>
          <p:nvPr/>
        </p:nvSpPr>
        <p:spPr>
          <a:xfrm>
            <a:off x="644039" y="5609487"/>
            <a:ext cx="681452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xmlns="" id="{8B1E2780-2326-D645-AE84-60EC0147936F}"/>
              </a:ext>
            </a:extLst>
          </p:cNvPr>
          <p:cNvSpPr/>
          <p:nvPr/>
        </p:nvSpPr>
        <p:spPr>
          <a:xfrm>
            <a:off x="2379447" y="5630294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xmlns="" id="{89590DB6-C767-5A41-AFDA-0D61C8FAE6FB}"/>
              </a:ext>
            </a:extLst>
          </p:cNvPr>
          <p:cNvSpPr/>
          <p:nvPr/>
        </p:nvSpPr>
        <p:spPr>
          <a:xfrm>
            <a:off x="4089803" y="5575624"/>
            <a:ext cx="681452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xmlns="" id="{353568C6-223B-6F41-9BC2-1E3D4FB709AE}"/>
              </a:ext>
            </a:extLst>
          </p:cNvPr>
          <p:cNvSpPr/>
          <p:nvPr/>
        </p:nvSpPr>
        <p:spPr>
          <a:xfrm>
            <a:off x="5753165" y="5596431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xmlns="" id="{C0D7DDCA-DFF5-0C49-9A86-13F5F2725142}"/>
              </a:ext>
            </a:extLst>
          </p:cNvPr>
          <p:cNvSpPr/>
          <p:nvPr/>
        </p:nvSpPr>
        <p:spPr>
          <a:xfrm>
            <a:off x="4101944" y="5690937"/>
            <a:ext cx="423128" cy="995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xmlns="" id="{13FC9A46-2B4A-6944-A647-9B1A90DDFAA4}"/>
              </a:ext>
            </a:extLst>
          </p:cNvPr>
          <p:cNvSpPr/>
          <p:nvPr/>
        </p:nvSpPr>
        <p:spPr>
          <a:xfrm>
            <a:off x="4219693" y="5724325"/>
            <a:ext cx="423128" cy="383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0E95AB81-97BF-0045-BEF0-C3806B644107}"/>
              </a:ext>
            </a:extLst>
          </p:cNvPr>
          <p:cNvSpPr/>
          <p:nvPr/>
        </p:nvSpPr>
        <p:spPr>
          <a:xfrm>
            <a:off x="616049" y="7160517"/>
            <a:ext cx="681452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xmlns="" id="{57869619-BAC8-0840-86A2-E0B1216A3E03}"/>
              </a:ext>
            </a:extLst>
          </p:cNvPr>
          <p:cNvSpPr/>
          <p:nvPr/>
        </p:nvSpPr>
        <p:spPr>
          <a:xfrm>
            <a:off x="2351457" y="7181324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xmlns="" id="{26DD7D0F-B3CB-034E-8EC9-16422FA6662C}"/>
              </a:ext>
            </a:extLst>
          </p:cNvPr>
          <p:cNvSpPr/>
          <p:nvPr/>
        </p:nvSpPr>
        <p:spPr>
          <a:xfrm>
            <a:off x="4089523" y="7179003"/>
            <a:ext cx="681452" cy="1602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xmlns="" id="{4AC31C07-34C0-E24C-B521-476341A0DABF}"/>
              </a:ext>
            </a:extLst>
          </p:cNvPr>
          <p:cNvSpPr/>
          <p:nvPr/>
        </p:nvSpPr>
        <p:spPr>
          <a:xfrm>
            <a:off x="5813847" y="7147461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xmlns="" id="{F7D5FBCE-48C0-F44F-86CB-BA5CD0A4D38C}"/>
              </a:ext>
            </a:extLst>
          </p:cNvPr>
          <p:cNvSpPr/>
          <p:nvPr/>
        </p:nvSpPr>
        <p:spPr>
          <a:xfrm>
            <a:off x="715601" y="8735576"/>
            <a:ext cx="681452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xmlns="" id="{60D26CEB-1145-C043-8AC8-58DB74B8C27A}"/>
              </a:ext>
            </a:extLst>
          </p:cNvPr>
          <p:cNvSpPr/>
          <p:nvPr/>
        </p:nvSpPr>
        <p:spPr>
          <a:xfrm>
            <a:off x="2291117" y="8717590"/>
            <a:ext cx="681452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xmlns="" id="{D396FD3B-529B-F341-AF9B-9FF4FA440762}"/>
              </a:ext>
            </a:extLst>
          </p:cNvPr>
          <p:cNvSpPr/>
          <p:nvPr/>
        </p:nvSpPr>
        <p:spPr>
          <a:xfrm>
            <a:off x="4044168" y="8701713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xmlns="" id="{F0F40B2C-8749-9248-8D2E-BE5539CB764D}"/>
              </a:ext>
            </a:extLst>
          </p:cNvPr>
          <p:cNvSpPr/>
          <p:nvPr/>
        </p:nvSpPr>
        <p:spPr>
          <a:xfrm>
            <a:off x="5824727" y="8722520"/>
            <a:ext cx="749597" cy="1762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chemeClr val="bg1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3326064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5</TotalTime>
  <Words>67</Words>
  <Application>Microsoft Office PowerPoint</Application>
  <PresentationFormat>A4 Paper (210x297 mm)</PresentationFormat>
  <Paragraphs>4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 Yan Yap</dc:creator>
  <cp:lastModifiedBy>749637</cp:lastModifiedBy>
  <cp:revision>101</cp:revision>
  <cp:lastPrinted>2021-05-17T07:53:20Z</cp:lastPrinted>
  <dcterms:created xsi:type="dcterms:W3CDTF">2021-04-06T10:33:17Z</dcterms:created>
  <dcterms:modified xsi:type="dcterms:W3CDTF">2021-09-23T20:49:13Z</dcterms:modified>
</cp:coreProperties>
</file>